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6C114A7-CD60-450D-AD8C-DD80EF1DD3D4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dditional File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0F1A583-6541-4A44-8F3E-30E2E3A5C759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1FF449-BA6A-47BD-BF2B-E8D4B18DA57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47BC3F-876F-4837-8F35-77B5C6CECA9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2C4A2B-3677-46A2-AD2D-C85A5A1EA0D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333555-B26D-47DB-82E3-3339EB46A65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5CC77F-683D-4153-80C1-3D30634421C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28B4B3-729E-442F-A1A5-DE1576ACBFF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5395A5-5859-46C5-88A6-F0B8706A78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15FA8B-0BAC-46ED-86D3-FDA937490A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36BE5B-3B16-4A5B-A3A1-92C7FD501B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B87E3D-6A30-4D47-9DE2-6EB525B0FB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29AAC2-D5FA-4209-BF3B-8EE34C1530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A05015-339D-4AAE-9F98-BAE6617472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67C1351-2AED-41EB-B18D-ACC96983A68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4" descr="K:\Maria Libera\Collaborations\Collaboration with Masoud breast samples\BRB  ANALYSIS\innate response\crosstalk nk and dendritic cells.jpg"/>
          <p:cNvPicPr/>
          <p:nvPr/>
        </p:nvPicPr>
        <p:blipFill>
          <a:blip r:embed="rId1"/>
          <a:srcRect l="0" t="2328" r="35" b="2328"/>
          <a:stretch/>
        </p:blipFill>
        <p:spPr>
          <a:xfrm>
            <a:off x="0" y="263520"/>
            <a:ext cx="9069480" cy="5222880"/>
          </a:xfrm>
          <a:prstGeom prst="rect">
            <a:avLst/>
          </a:prstGeom>
          <a:ln w="0">
            <a:noFill/>
          </a:ln>
        </p:spPr>
      </p:pic>
      <p:grpSp>
        <p:nvGrpSpPr>
          <p:cNvPr id="49" name="Group 7"/>
          <p:cNvGrpSpPr/>
          <p:nvPr/>
        </p:nvGrpSpPr>
        <p:grpSpPr>
          <a:xfrm>
            <a:off x="7043760" y="4834080"/>
            <a:ext cx="2265480" cy="2027160"/>
            <a:chOff x="7043760" y="4834080"/>
            <a:chExt cx="2265480" cy="2027160"/>
          </a:xfrm>
        </p:grpSpPr>
        <p:pic>
          <p:nvPicPr>
            <p:cNvPr id="50" name="Picture 2" descr="An external file that holds a picture, illustration, etc.&#10;Object name is 1471-2164-10-301-6.jpg Object name is 1471-2164-10-301-6.jpg"/>
            <p:cNvPicPr/>
            <p:nvPr/>
          </p:nvPicPr>
          <p:blipFill>
            <a:blip r:embed="rId2"/>
            <a:srcRect l="2675" t="50571" r="92762" b="0"/>
            <a:stretch/>
          </p:blipFill>
          <p:spPr>
            <a:xfrm>
              <a:off x="7043760" y="5060880"/>
              <a:ext cx="335160" cy="1800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TextBox 9"/>
            <p:cNvSpPr/>
            <p:nvPr/>
          </p:nvSpPr>
          <p:spPr>
            <a:xfrm>
              <a:off x="7397640" y="5007960"/>
              <a:ext cx="1911600" cy="1798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Chemical or Drug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Cytokine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Enzyme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G-protein Coupled Recepto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Group or Complex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Growth Facto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Ion Channel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Kinase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Ligand-dependent Nuclear Recepto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eptidase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hosphatase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Transcription Regulato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Translation Regulato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Transmembrane Recepto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Transporte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Othe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Box 10"/>
            <p:cNvSpPr/>
            <p:nvPr/>
          </p:nvSpPr>
          <p:spPr>
            <a:xfrm>
              <a:off x="7059960" y="4834080"/>
              <a:ext cx="207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egen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11"/>
            <p:cNvSpPr/>
            <p:nvPr/>
          </p:nvSpPr>
          <p:spPr>
            <a:xfrm>
              <a:off x="7065720" y="4865760"/>
              <a:ext cx="2030760" cy="1957320"/>
            </a:xfrm>
            <a:prstGeom prst="rect">
              <a:avLst/>
            </a:prstGeom>
            <a:noFill/>
            <a:ln w="25560">
              <a:solidFill>
                <a:srgbClr val="bfbfbf">
                  <a:alpha val="65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7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23T18:40:09Z</dcterms:created>
  <dc:creator>asciertoml</dc:creator>
  <dc:description/>
  <dc:language>en-US</dc:language>
  <cp:lastModifiedBy>asciertoml</cp:lastModifiedBy>
  <dcterms:modified xsi:type="dcterms:W3CDTF">2011-11-30T18:40:22Z</dcterms:modified>
  <cp:revision>313</cp:revision>
  <dc:subject/>
  <dc:title>Slide 1</dc:title>
</cp:coreProperties>
</file>